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4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7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openxmlformats.org/officeDocument/2006/relationships/image" Target="../media/image6.png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6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 descr="Ein Bild, das drinnen, Pizza, Foto, sitzend enthält.&#10;&#10;Automatisch generierte Beschreibung">
            <a:extLst>
              <a:ext uri="{FF2B5EF4-FFF2-40B4-BE49-F238E27FC236}">
                <a16:creationId xmlns="" xmlns:a16="http://schemas.microsoft.com/office/drawing/2014/main" id="{2DEB27F3-F912-3A4B-8C1D-89E2CE7FF98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38144" y="6506729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92">
            <a:extLst>
              <a:ext uri="{FF2B5EF4-FFF2-40B4-BE49-F238E27FC236}">
                <a16:creationId xmlns="" xmlns:a16="http://schemas.microsoft.com/office/drawing/2014/main" id="{58AB2654-1DE4-964B-B258-CBE98527D8AF}"/>
              </a:ext>
            </a:extLst>
          </p:cNvPr>
          <p:cNvSpPr txBox="1"/>
          <p:nvPr/>
        </p:nvSpPr>
        <p:spPr>
          <a:xfrm>
            <a:off x="152400" y="508456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Grafik 7" descr="Ein Bild, das Rock, Baum enthält.&#10;&#10;Automatisch generierte Beschreibung">
            <a:extLst>
              <a:ext uri="{FF2B5EF4-FFF2-40B4-BE49-F238E27FC236}">
                <a16:creationId xmlns="" xmlns:a16="http://schemas.microsoft.com/office/drawing/2014/main" id="{4BF8B29F-60FF-694F-A383-DAAC81C34E9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9658" y="538459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Grafik 10" descr="Ein Bild, das Gras, Kind, klein, alt enthält.&#10;&#10;Automatisch generierte Beschreibung">
            <a:extLst>
              <a:ext uri="{FF2B5EF4-FFF2-40B4-BE49-F238E27FC236}">
                <a16:creationId xmlns="" xmlns:a16="http://schemas.microsoft.com/office/drawing/2014/main" id="{488D9CDF-0115-A245-9A86-8C2320AB9956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38144" y="538459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Rechteck 11">
            <a:extLst>
              <a:ext uri="{FF2B5EF4-FFF2-40B4-BE49-F238E27FC236}">
                <a16:creationId xmlns="" xmlns:a16="http://schemas.microsoft.com/office/drawing/2014/main" id="{54E2D783-51E8-9E4A-B6A0-F854838FDE0A}"/>
              </a:ext>
            </a:extLst>
          </p:cNvPr>
          <p:cNvSpPr/>
          <p:nvPr/>
        </p:nvSpPr>
        <p:spPr>
          <a:xfrm>
            <a:off x="1371600" y="958304"/>
            <a:ext cx="914400" cy="54015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4" name="Gerade Verbindung 13">
            <a:extLst>
              <a:ext uri="{FF2B5EF4-FFF2-40B4-BE49-F238E27FC236}">
                <a16:creationId xmlns="" xmlns:a16="http://schemas.microsoft.com/office/drawing/2014/main" id="{03549112-1D59-734A-BCAC-808431DAE8AC}"/>
              </a:ext>
            </a:extLst>
          </p:cNvPr>
          <p:cNvCxnSpPr/>
          <p:nvPr/>
        </p:nvCxnSpPr>
        <p:spPr>
          <a:xfrm flipV="1">
            <a:off x="2286000" y="534114"/>
            <a:ext cx="1143000" cy="4241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 Verbindung 14">
            <a:extLst>
              <a:ext uri="{FF2B5EF4-FFF2-40B4-BE49-F238E27FC236}">
                <a16:creationId xmlns="" xmlns:a16="http://schemas.microsoft.com/office/drawing/2014/main" id="{41BBC011-1044-9F4C-AD2D-03D4D9641210}"/>
              </a:ext>
            </a:extLst>
          </p:cNvPr>
          <p:cNvCxnSpPr>
            <a:cxnSpLocks/>
          </p:cNvCxnSpPr>
          <p:nvPr/>
        </p:nvCxnSpPr>
        <p:spPr>
          <a:xfrm>
            <a:off x="2286000" y="1498460"/>
            <a:ext cx="1133857" cy="95999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92">
            <a:extLst>
              <a:ext uri="{FF2B5EF4-FFF2-40B4-BE49-F238E27FC236}">
                <a16:creationId xmlns="" xmlns:a16="http://schemas.microsoft.com/office/drawing/2014/main" id="{160AA658-9DC2-2547-A0B2-F35D127519E2}"/>
              </a:ext>
            </a:extLst>
          </p:cNvPr>
          <p:cNvSpPr txBox="1"/>
          <p:nvPr/>
        </p:nvSpPr>
        <p:spPr>
          <a:xfrm>
            <a:off x="152400" y="251460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4" name="Grafik 23" descr="Ein Bild, das Foto, alt, weiß, schwarz enthält.&#10;&#10;Automatisch generierte Beschreibung">
            <a:extLst>
              <a:ext uri="{FF2B5EF4-FFF2-40B4-BE49-F238E27FC236}">
                <a16:creationId xmlns="" xmlns:a16="http://schemas.microsoft.com/office/drawing/2014/main" id="{023CA43A-B664-234F-99C5-B6D3F24B82DC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6960" y="2544602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Grafik 25" descr="Ein Bild, das Tier, Pizza, Stück, sitzend enthält.&#10;&#10;Automatisch generierte Beschreibung">
            <a:extLst>
              <a:ext uri="{FF2B5EF4-FFF2-40B4-BE49-F238E27FC236}">
                <a16:creationId xmlns="" xmlns:a16="http://schemas.microsoft.com/office/drawing/2014/main" id="{F40871D2-FEA6-3345-97C5-F8F2A8DD961A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29000" y="2544602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92">
            <a:extLst>
              <a:ext uri="{FF2B5EF4-FFF2-40B4-BE49-F238E27FC236}">
                <a16:creationId xmlns="" xmlns:a16="http://schemas.microsoft.com/office/drawing/2014/main" id="{BB45956F-8730-D547-B4CC-29408A4B484A}"/>
              </a:ext>
            </a:extLst>
          </p:cNvPr>
          <p:cNvSpPr txBox="1"/>
          <p:nvPr/>
        </p:nvSpPr>
        <p:spPr>
          <a:xfrm>
            <a:off x="152400" y="44958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29" name="Grafik 28" descr="Ein Bild, das alt, weiß, sitzend, klein enthält.&#10;&#10;Automatisch generierte Beschreibung">
            <a:extLst>
              <a:ext uri="{FF2B5EF4-FFF2-40B4-BE49-F238E27FC236}">
                <a16:creationId xmlns="" xmlns:a16="http://schemas.microsoft.com/office/drawing/2014/main" id="{2BE12DD3-600C-E044-BEB7-DD76DEA3A801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6960" y="4525803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" name="Grafik 30" descr="Ein Bild, das Foto, alt, sitzend, weiß enthält.&#10;&#10;Automatisch generierte Beschreibung">
            <a:extLst>
              <a:ext uri="{FF2B5EF4-FFF2-40B4-BE49-F238E27FC236}">
                <a16:creationId xmlns="" xmlns:a16="http://schemas.microsoft.com/office/drawing/2014/main" id="{1FC692F7-6021-9B43-AB30-B8AD38ED46E9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429000" y="4525803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TextBox 92">
            <a:extLst>
              <a:ext uri="{FF2B5EF4-FFF2-40B4-BE49-F238E27FC236}">
                <a16:creationId xmlns="" xmlns:a16="http://schemas.microsoft.com/office/drawing/2014/main" id="{3BECAFE6-3D7C-FD4D-9AE9-4443890F359E}"/>
              </a:ext>
            </a:extLst>
          </p:cNvPr>
          <p:cNvSpPr txBox="1"/>
          <p:nvPr/>
        </p:nvSpPr>
        <p:spPr>
          <a:xfrm>
            <a:off x="152400" y="64770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7" name="Grafik 6" descr="Ein Bild, das Tier, Pizza, Frosch, alt enthält.&#10;&#10;Automatisch generierte Beschreibung">
            <a:extLst>
              <a:ext uri="{FF2B5EF4-FFF2-40B4-BE49-F238E27FC236}">
                <a16:creationId xmlns="" xmlns:a16="http://schemas.microsoft.com/office/drawing/2014/main" id="{3C7B54F9-E33D-CB4B-A042-9D84C05022C7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36960" y="6506729"/>
            <a:ext cx="2880000" cy="19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" name="Textfeld 12">
            <a:extLst>
              <a:ext uri="{FF2B5EF4-FFF2-40B4-BE49-F238E27FC236}">
                <a16:creationId xmlns="" xmlns:a16="http://schemas.microsoft.com/office/drawing/2014/main" id="{9090ECD5-8E25-BC41-919C-CA6F116D08F9}"/>
              </a:ext>
            </a:extLst>
          </p:cNvPr>
          <p:cNvSpPr txBox="1"/>
          <p:nvPr/>
        </p:nvSpPr>
        <p:spPr>
          <a:xfrm>
            <a:off x="4296115" y="950867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="" xmlns:a16="http://schemas.microsoft.com/office/drawing/2014/main" id="{93A32C52-5B4A-934D-B95D-E3A0776074B8}"/>
              </a:ext>
            </a:extLst>
          </p:cNvPr>
          <p:cNvSpPr txBox="1"/>
          <p:nvPr/>
        </p:nvSpPr>
        <p:spPr>
          <a:xfrm>
            <a:off x="4958851" y="822994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="" xmlns:a16="http://schemas.microsoft.com/office/drawing/2014/main" id="{FAB3B1A4-C2BF-994F-9F3A-D3C7274C3148}"/>
              </a:ext>
            </a:extLst>
          </p:cNvPr>
          <p:cNvSpPr txBox="1"/>
          <p:nvPr/>
        </p:nvSpPr>
        <p:spPr>
          <a:xfrm>
            <a:off x="5446684" y="3515370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="" xmlns:a16="http://schemas.microsoft.com/office/drawing/2014/main" id="{D085E60C-65E6-194F-BA28-71D0B6738A3A}"/>
              </a:ext>
            </a:extLst>
          </p:cNvPr>
          <p:cNvSpPr txBox="1"/>
          <p:nvPr/>
        </p:nvSpPr>
        <p:spPr>
          <a:xfrm>
            <a:off x="4819860" y="2959588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="" xmlns:a16="http://schemas.microsoft.com/office/drawing/2014/main" id="{16D8A1FF-600D-D542-BFD2-56605A63C84D}"/>
              </a:ext>
            </a:extLst>
          </p:cNvPr>
          <p:cNvSpPr txBox="1"/>
          <p:nvPr/>
        </p:nvSpPr>
        <p:spPr>
          <a:xfrm>
            <a:off x="5490908" y="5301137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="" xmlns:a16="http://schemas.microsoft.com/office/drawing/2014/main" id="{64CFA283-18A2-F346-AB27-670AF4CD966F}"/>
              </a:ext>
            </a:extLst>
          </p:cNvPr>
          <p:cNvSpPr txBox="1"/>
          <p:nvPr/>
        </p:nvSpPr>
        <p:spPr>
          <a:xfrm>
            <a:off x="1816598" y="5668561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="" xmlns:a16="http://schemas.microsoft.com/office/drawing/2014/main" id="{0985B989-54DF-1946-9700-6256B2E2A641}"/>
              </a:ext>
            </a:extLst>
          </p:cNvPr>
          <p:cNvSpPr txBox="1"/>
          <p:nvPr/>
        </p:nvSpPr>
        <p:spPr>
          <a:xfrm>
            <a:off x="4341067" y="7668537"/>
            <a:ext cx="292068" cy="18466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="" xmlns:a16="http://schemas.microsoft.com/office/drawing/2014/main" id="{A53189F9-0BF5-AD47-93E9-9B64104403AB}"/>
              </a:ext>
            </a:extLst>
          </p:cNvPr>
          <p:cNvSpPr txBox="1"/>
          <p:nvPr/>
        </p:nvSpPr>
        <p:spPr>
          <a:xfrm>
            <a:off x="4846681" y="1165659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>
            <a:extLst>
              <a:ext uri="{FF2B5EF4-FFF2-40B4-BE49-F238E27FC236}">
                <a16:creationId xmlns="" xmlns:a16="http://schemas.microsoft.com/office/drawing/2014/main" id="{52AA1CAF-9211-2B4F-916F-5722E640B692}"/>
              </a:ext>
            </a:extLst>
          </p:cNvPr>
          <p:cNvSpPr txBox="1"/>
          <p:nvPr/>
        </p:nvSpPr>
        <p:spPr>
          <a:xfrm>
            <a:off x="3929493" y="3235038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>
            <a:extLst>
              <a:ext uri="{FF2B5EF4-FFF2-40B4-BE49-F238E27FC236}">
                <a16:creationId xmlns="" xmlns:a16="http://schemas.microsoft.com/office/drawing/2014/main" id="{0E747655-38F7-4F4D-8BAD-1EE1560C121D}"/>
              </a:ext>
            </a:extLst>
          </p:cNvPr>
          <p:cNvSpPr txBox="1"/>
          <p:nvPr/>
        </p:nvSpPr>
        <p:spPr>
          <a:xfrm>
            <a:off x="5022711" y="3436874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>
            <a:extLst>
              <a:ext uri="{FF2B5EF4-FFF2-40B4-BE49-F238E27FC236}">
                <a16:creationId xmlns="" xmlns:a16="http://schemas.microsoft.com/office/drawing/2014/main" id="{D485F1E0-68A5-C54B-BD5A-140721A9278E}"/>
              </a:ext>
            </a:extLst>
          </p:cNvPr>
          <p:cNvSpPr txBox="1"/>
          <p:nvPr/>
        </p:nvSpPr>
        <p:spPr>
          <a:xfrm>
            <a:off x="2495939" y="5548529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>
            <a:extLst>
              <a:ext uri="{FF2B5EF4-FFF2-40B4-BE49-F238E27FC236}">
                <a16:creationId xmlns="" xmlns:a16="http://schemas.microsoft.com/office/drawing/2014/main" id="{C9B19526-4C7D-DE43-8EF3-75738C34822B}"/>
              </a:ext>
            </a:extLst>
          </p:cNvPr>
          <p:cNvSpPr txBox="1"/>
          <p:nvPr/>
        </p:nvSpPr>
        <p:spPr>
          <a:xfrm>
            <a:off x="5328792" y="5799707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>
            <a:extLst>
              <a:ext uri="{FF2B5EF4-FFF2-40B4-BE49-F238E27FC236}">
                <a16:creationId xmlns="" xmlns:a16="http://schemas.microsoft.com/office/drawing/2014/main" id="{2B629CD2-6FF3-124E-B235-4F85E77D1569}"/>
              </a:ext>
            </a:extLst>
          </p:cNvPr>
          <p:cNvSpPr txBox="1"/>
          <p:nvPr/>
        </p:nvSpPr>
        <p:spPr>
          <a:xfrm>
            <a:off x="4523851" y="7520808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feld 40">
            <a:extLst>
              <a:ext uri="{FF2B5EF4-FFF2-40B4-BE49-F238E27FC236}">
                <a16:creationId xmlns="" xmlns:a16="http://schemas.microsoft.com/office/drawing/2014/main" id="{58566157-326E-1C46-94C9-E6B2466AD6CB}"/>
              </a:ext>
            </a:extLst>
          </p:cNvPr>
          <p:cNvSpPr txBox="1"/>
          <p:nvPr/>
        </p:nvSpPr>
        <p:spPr>
          <a:xfrm>
            <a:off x="5850524" y="7380567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feld 41">
            <a:extLst>
              <a:ext uri="{FF2B5EF4-FFF2-40B4-BE49-F238E27FC236}">
                <a16:creationId xmlns="" xmlns:a16="http://schemas.microsoft.com/office/drawing/2014/main" id="{09714ED8-236E-F241-842C-BE53D25F37E9}"/>
              </a:ext>
            </a:extLst>
          </p:cNvPr>
          <p:cNvSpPr txBox="1"/>
          <p:nvPr/>
        </p:nvSpPr>
        <p:spPr>
          <a:xfrm>
            <a:off x="5618130" y="7073105"/>
            <a:ext cx="292068" cy="18466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="" xmlns:a16="http://schemas.microsoft.com/office/drawing/2014/main" id="{CA8FC8D7-6AF2-7840-B0D8-6B094DED59F9}"/>
              </a:ext>
            </a:extLst>
          </p:cNvPr>
          <p:cNvSpPr txBox="1"/>
          <p:nvPr/>
        </p:nvSpPr>
        <p:spPr>
          <a:xfrm>
            <a:off x="1563684" y="7202407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>
            <a:extLst>
              <a:ext uri="{FF2B5EF4-FFF2-40B4-BE49-F238E27FC236}">
                <a16:creationId xmlns="" xmlns:a16="http://schemas.microsoft.com/office/drawing/2014/main" id="{0A4A14D6-2F3D-9049-BF04-F693A6AD256C}"/>
              </a:ext>
            </a:extLst>
          </p:cNvPr>
          <p:cNvSpPr txBox="1"/>
          <p:nvPr/>
        </p:nvSpPr>
        <p:spPr>
          <a:xfrm>
            <a:off x="1848106" y="7860734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feld 44">
            <a:extLst>
              <a:ext uri="{FF2B5EF4-FFF2-40B4-BE49-F238E27FC236}">
                <a16:creationId xmlns="" xmlns:a16="http://schemas.microsoft.com/office/drawing/2014/main" id="{29483B91-DC4A-F949-B77C-301D0AA8C74B}"/>
              </a:ext>
            </a:extLst>
          </p:cNvPr>
          <p:cNvSpPr txBox="1"/>
          <p:nvPr/>
        </p:nvSpPr>
        <p:spPr>
          <a:xfrm>
            <a:off x="1224305" y="6826529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feld 45">
            <a:extLst>
              <a:ext uri="{FF2B5EF4-FFF2-40B4-BE49-F238E27FC236}">
                <a16:creationId xmlns="" xmlns:a16="http://schemas.microsoft.com/office/drawing/2014/main" id="{0D7E5FCE-0846-A146-AB56-6EEE350426EB}"/>
              </a:ext>
            </a:extLst>
          </p:cNvPr>
          <p:cNvSpPr txBox="1"/>
          <p:nvPr/>
        </p:nvSpPr>
        <p:spPr>
          <a:xfrm>
            <a:off x="992619" y="7110074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>
            <a:extLst>
              <a:ext uri="{FF2B5EF4-FFF2-40B4-BE49-F238E27FC236}">
                <a16:creationId xmlns="" xmlns:a16="http://schemas.microsoft.com/office/drawing/2014/main" id="{F1252EE3-49D3-3F44-9906-68E066D805CE}"/>
              </a:ext>
            </a:extLst>
          </p:cNvPr>
          <p:cNvSpPr txBox="1"/>
          <p:nvPr/>
        </p:nvSpPr>
        <p:spPr>
          <a:xfrm>
            <a:off x="2521587" y="5104501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feld 47">
            <a:extLst>
              <a:ext uri="{FF2B5EF4-FFF2-40B4-BE49-F238E27FC236}">
                <a16:creationId xmlns="" xmlns:a16="http://schemas.microsoft.com/office/drawing/2014/main" id="{2FA9D622-0279-A245-8E53-2661AAE26E42}"/>
              </a:ext>
            </a:extLst>
          </p:cNvPr>
          <p:cNvSpPr txBox="1"/>
          <p:nvPr/>
        </p:nvSpPr>
        <p:spPr>
          <a:xfrm>
            <a:off x="2705694" y="5958141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48">
            <a:extLst>
              <a:ext uri="{FF2B5EF4-FFF2-40B4-BE49-F238E27FC236}">
                <a16:creationId xmlns="" xmlns:a16="http://schemas.microsoft.com/office/drawing/2014/main" id="{9D148635-88DB-8A41-9AA3-E763D42B2058}"/>
              </a:ext>
            </a:extLst>
          </p:cNvPr>
          <p:cNvSpPr txBox="1"/>
          <p:nvPr/>
        </p:nvSpPr>
        <p:spPr>
          <a:xfrm>
            <a:off x="2682048" y="6273695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>
            <a:extLst>
              <a:ext uri="{FF2B5EF4-FFF2-40B4-BE49-F238E27FC236}">
                <a16:creationId xmlns="" xmlns:a16="http://schemas.microsoft.com/office/drawing/2014/main" id="{AB5D90DA-F7AB-164E-A6D0-6402B3D835F3}"/>
              </a:ext>
            </a:extLst>
          </p:cNvPr>
          <p:cNvSpPr txBox="1"/>
          <p:nvPr/>
        </p:nvSpPr>
        <p:spPr>
          <a:xfrm>
            <a:off x="1884606" y="4196640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>
            <a:extLst>
              <a:ext uri="{FF2B5EF4-FFF2-40B4-BE49-F238E27FC236}">
                <a16:creationId xmlns="" xmlns:a16="http://schemas.microsoft.com/office/drawing/2014/main" id="{B87A9F30-2934-434F-AA6E-16B47B77F58E}"/>
              </a:ext>
            </a:extLst>
          </p:cNvPr>
          <p:cNvSpPr txBox="1"/>
          <p:nvPr/>
        </p:nvSpPr>
        <p:spPr>
          <a:xfrm>
            <a:off x="1484211" y="1886126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>
            <a:extLst>
              <a:ext uri="{FF2B5EF4-FFF2-40B4-BE49-F238E27FC236}">
                <a16:creationId xmlns="" xmlns:a16="http://schemas.microsoft.com/office/drawing/2014/main" id="{BFCB5A91-3D80-EA44-B0EE-1802FD0D7DE6}"/>
              </a:ext>
            </a:extLst>
          </p:cNvPr>
          <p:cNvSpPr txBox="1"/>
          <p:nvPr/>
        </p:nvSpPr>
        <p:spPr>
          <a:xfrm>
            <a:off x="2141915" y="1641749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feld 52">
            <a:extLst>
              <a:ext uri="{FF2B5EF4-FFF2-40B4-BE49-F238E27FC236}">
                <a16:creationId xmlns="" xmlns:a16="http://schemas.microsoft.com/office/drawing/2014/main" id="{BBF7A9E6-EEF0-C94F-ADFC-07AA2C973D1E}"/>
              </a:ext>
            </a:extLst>
          </p:cNvPr>
          <p:cNvSpPr txBox="1"/>
          <p:nvPr/>
        </p:nvSpPr>
        <p:spPr>
          <a:xfrm>
            <a:off x="627390" y="1701460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feld 53">
            <a:extLst>
              <a:ext uri="{FF2B5EF4-FFF2-40B4-BE49-F238E27FC236}">
                <a16:creationId xmlns="" xmlns:a16="http://schemas.microsoft.com/office/drawing/2014/main" id="{F5FC87E7-1EE4-564D-85C4-F9428D628BF7}"/>
              </a:ext>
            </a:extLst>
          </p:cNvPr>
          <p:cNvSpPr txBox="1"/>
          <p:nvPr/>
        </p:nvSpPr>
        <p:spPr>
          <a:xfrm>
            <a:off x="1242762" y="1506930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feld 54">
            <a:extLst>
              <a:ext uri="{FF2B5EF4-FFF2-40B4-BE49-F238E27FC236}">
                <a16:creationId xmlns="" xmlns:a16="http://schemas.microsoft.com/office/drawing/2014/main" id="{E85970CF-C37D-0842-8CB3-75CB23B4C834}"/>
              </a:ext>
            </a:extLst>
          </p:cNvPr>
          <p:cNvSpPr txBox="1"/>
          <p:nvPr/>
        </p:nvSpPr>
        <p:spPr>
          <a:xfrm>
            <a:off x="2326311" y="664075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feld 55">
            <a:extLst>
              <a:ext uri="{FF2B5EF4-FFF2-40B4-BE49-F238E27FC236}">
                <a16:creationId xmlns="" xmlns:a16="http://schemas.microsoft.com/office/drawing/2014/main" id="{DA0D687D-77D9-3741-9DA2-D078F59F2098}"/>
              </a:ext>
            </a:extLst>
          </p:cNvPr>
          <p:cNvSpPr txBox="1"/>
          <p:nvPr/>
        </p:nvSpPr>
        <p:spPr>
          <a:xfrm>
            <a:off x="3721052" y="1880316"/>
            <a:ext cx="32092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feld 56">
            <a:extLst>
              <a:ext uri="{FF2B5EF4-FFF2-40B4-BE49-F238E27FC236}">
                <a16:creationId xmlns="" xmlns:a16="http://schemas.microsoft.com/office/drawing/2014/main" id="{FB53EE78-5C29-954F-8D16-C022B82B4A88}"/>
              </a:ext>
            </a:extLst>
          </p:cNvPr>
          <p:cNvSpPr txBox="1"/>
          <p:nvPr/>
        </p:nvSpPr>
        <p:spPr>
          <a:xfrm>
            <a:off x="5111928" y="6931696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Rechteck 57">
            <a:extLst>
              <a:ext uri="{FF2B5EF4-FFF2-40B4-BE49-F238E27FC236}">
                <a16:creationId xmlns="" xmlns:a16="http://schemas.microsoft.com/office/drawing/2014/main" id="{10D14E37-DDE5-6845-9E58-C2AACF8248CC}"/>
              </a:ext>
            </a:extLst>
          </p:cNvPr>
          <p:cNvSpPr/>
          <p:nvPr/>
        </p:nvSpPr>
        <p:spPr>
          <a:xfrm>
            <a:off x="2126512" y="7682989"/>
            <a:ext cx="914400" cy="540155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59" name="Gerade Verbindung 58">
            <a:extLst>
              <a:ext uri="{FF2B5EF4-FFF2-40B4-BE49-F238E27FC236}">
                <a16:creationId xmlns="" xmlns:a16="http://schemas.microsoft.com/office/drawing/2014/main" id="{4187C119-04D7-4A4B-9A84-F98A4E284D7D}"/>
              </a:ext>
            </a:extLst>
          </p:cNvPr>
          <p:cNvCxnSpPr>
            <a:cxnSpLocks/>
          </p:cNvCxnSpPr>
          <p:nvPr/>
        </p:nvCxnSpPr>
        <p:spPr>
          <a:xfrm flipV="1">
            <a:off x="3040912" y="6494171"/>
            <a:ext cx="378945" cy="118881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Gerade Verbindung 59">
            <a:extLst>
              <a:ext uri="{FF2B5EF4-FFF2-40B4-BE49-F238E27FC236}">
                <a16:creationId xmlns="" xmlns:a16="http://schemas.microsoft.com/office/drawing/2014/main" id="{DB747888-C8E0-8F44-879C-0CED1FBE905C}"/>
              </a:ext>
            </a:extLst>
          </p:cNvPr>
          <p:cNvCxnSpPr>
            <a:cxnSpLocks/>
          </p:cNvCxnSpPr>
          <p:nvPr/>
        </p:nvCxnSpPr>
        <p:spPr>
          <a:xfrm>
            <a:off x="3022320" y="8223144"/>
            <a:ext cx="415824" cy="20358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feld 63">
            <a:extLst>
              <a:ext uri="{FF2B5EF4-FFF2-40B4-BE49-F238E27FC236}">
                <a16:creationId xmlns="" xmlns:a16="http://schemas.microsoft.com/office/drawing/2014/main" id="{7C999F1D-23FD-9741-83FE-2B1796545732}"/>
              </a:ext>
            </a:extLst>
          </p:cNvPr>
          <p:cNvSpPr txBox="1"/>
          <p:nvPr/>
        </p:nvSpPr>
        <p:spPr>
          <a:xfrm>
            <a:off x="4583675" y="5508475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u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>
            <a:extLst>
              <a:ext uri="{FF2B5EF4-FFF2-40B4-BE49-F238E27FC236}">
                <a16:creationId xmlns="" xmlns:a16="http://schemas.microsoft.com/office/drawing/2014/main" id="{B08ABD82-65E7-934C-B3D8-1702F52BD731}"/>
              </a:ext>
            </a:extLst>
          </p:cNvPr>
          <p:cNvSpPr txBox="1"/>
          <p:nvPr/>
        </p:nvSpPr>
        <p:spPr>
          <a:xfrm>
            <a:off x="5636942" y="3822832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>
            <a:extLst>
              <a:ext uri="{FF2B5EF4-FFF2-40B4-BE49-F238E27FC236}">
                <a16:creationId xmlns="" xmlns:a16="http://schemas.microsoft.com/office/drawing/2014/main" id="{4DCF95EC-AE14-3F48-9038-97771C7BD681}"/>
              </a:ext>
            </a:extLst>
          </p:cNvPr>
          <p:cNvSpPr txBox="1"/>
          <p:nvPr/>
        </p:nvSpPr>
        <p:spPr>
          <a:xfrm>
            <a:off x="1768508" y="3855186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60">
            <a:extLst>
              <a:ext uri="{FF2B5EF4-FFF2-40B4-BE49-F238E27FC236}">
                <a16:creationId xmlns="" xmlns:a16="http://schemas.microsoft.com/office/drawing/2014/main" id="{3C8DC752-FAB0-6A47-8437-0C65E147E1C5}"/>
              </a:ext>
            </a:extLst>
          </p:cNvPr>
          <p:cNvSpPr txBox="1"/>
          <p:nvPr/>
        </p:nvSpPr>
        <p:spPr>
          <a:xfrm>
            <a:off x="435585" y="528404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="" xmlns:a16="http://schemas.microsoft.com/office/drawing/2014/main" id="{840AE192-FCF1-5547-B835-A1D8AE3EAF11}"/>
              </a:ext>
            </a:extLst>
          </p:cNvPr>
          <p:cNvSpPr txBox="1"/>
          <p:nvPr/>
        </p:nvSpPr>
        <p:spPr>
          <a:xfrm>
            <a:off x="3419857" y="528404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DMSO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="" xmlns:a16="http://schemas.microsoft.com/office/drawing/2014/main" id="{AB210062-2D86-9646-AA9A-8107B4B1C65B}"/>
              </a:ext>
            </a:extLst>
          </p:cNvPr>
          <p:cNvSpPr txBox="1"/>
          <p:nvPr/>
        </p:nvSpPr>
        <p:spPr>
          <a:xfrm>
            <a:off x="436960" y="2539081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AUY922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="" xmlns:a16="http://schemas.microsoft.com/office/drawing/2014/main" id="{9E27329C-A0AA-FC40-A42E-F43461182C1F}"/>
              </a:ext>
            </a:extLst>
          </p:cNvPr>
          <p:cNvSpPr txBox="1"/>
          <p:nvPr/>
        </p:nvSpPr>
        <p:spPr>
          <a:xfrm>
            <a:off x="3431402" y="2545050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AUY922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="" xmlns:a16="http://schemas.microsoft.com/office/drawing/2014/main" id="{6F91893F-F32C-5F4E-838B-5E208A337766}"/>
              </a:ext>
            </a:extLst>
          </p:cNvPr>
          <p:cNvSpPr txBox="1"/>
          <p:nvPr/>
        </p:nvSpPr>
        <p:spPr>
          <a:xfrm>
            <a:off x="434479" y="6506497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AUY-VE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="" xmlns:a16="http://schemas.microsoft.com/office/drawing/2014/main" id="{44CCB4BB-60AA-904B-980A-C59FBA98D31E}"/>
              </a:ext>
            </a:extLst>
          </p:cNvPr>
          <p:cNvSpPr txBox="1"/>
          <p:nvPr/>
        </p:nvSpPr>
        <p:spPr>
          <a:xfrm>
            <a:off x="3431402" y="6506496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AUY-VE</a:t>
            </a:r>
          </a:p>
        </p:txBody>
      </p:sp>
      <p:sp>
        <p:nvSpPr>
          <p:cNvPr id="74" name="Textfeld 73">
            <a:extLst>
              <a:ext uri="{FF2B5EF4-FFF2-40B4-BE49-F238E27FC236}">
                <a16:creationId xmlns="" xmlns:a16="http://schemas.microsoft.com/office/drawing/2014/main" id="{B6A84ECB-CBF5-F541-9836-617EC0273F50}"/>
              </a:ext>
            </a:extLst>
          </p:cNvPr>
          <p:cNvSpPr txBox="1"/>
          <p:nvPr/>
        </p:nvSpPr>
        <p:spPr>
          <a:xfrm>
            <a:off x="434479" y="4523202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VE821</a:t>
            </a:r>
          </a:p>
        </p:txBody>
      </p:sp>
      <p:sp>
        <p:nvSpPr>
          <p:cNvPr id="75" name="Textfeld 74">
            <a:extLst>
              <a:ext uri="{FF2B5EF4-FFF2-40B4-BE49-F238E27FC236}">
                <a16:creationId xmlns="" xmlns:a16="http://schemas.microsoft.com/office/drawing/2014/main" id="{85273C58-6780-5847-B854-7661B528E5E4}"/>
              </a:ext>
            </a:extLst>
          </p:cNvPr>
          <p:cNvSpPr txBox="1"/>
          <p:nvPr/>
        </p:nvSpPr>
        <p:spPr>
          <a:xfrm>
            <a:off x="3431402" y="4523202"/>
            <a:ext cx="504000" cy="18000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600" dirty="0">
                <a:latin typeface="Arial" panose="020B0604020202020204" pitchFamily="34" charset="0"/>
                <a:cs typeface="Arial" panose="020B0604020202020204" pitchFamily="34" charset="0"/>
              </a:rPr>
              <a:t>VE821</a:t>
            </a:r>
          </a:p>
        </p:txBody>
      </p:sp>
      <p:sp>
        <p:nvSpPr>
          <p:cNvPr id="77" name="Rechteck 8">
            <a:extLst>
              <a:ext uri="{FF2B5EF4-FFF2-40B4-BE49-F238E27FC236}">
                <a16:creationId xmlns="" xmlns:a16="http://schemas.microsoft.com/office/drawing/2014/main" id="{55ABAC3B-446B-6940-80D5-AA23D055BBCB}"/>
              </a:ext>
            </a:extLst>
          </p:cNvPr>
          <p:cNvSpPr/>
          <p:nvPr/>
        </p:nvSpPr>
        <p:spPr>
          <a:xfrm>
            <a:off x="296029" y="8534400"/>
            <a:ext cx="6229957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6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Accumulation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ntracellular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efects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in WE-68 </a:t>
            </a:r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E-68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 (B), 2 µM VE821 (C)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hei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mbinatio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D). DMSO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(A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ntracellular structures were analyzed by transmission electron microscopy (TEM) and are labeled in red: lysosome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lys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mitochondria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endoplasmic reticulum (ER), nucleus (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uc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autophagosome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auto), </a:t>
            </a:r>
            <a:r>
              <a:rPr lang="el-GR" sz="11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-glycoge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ranule (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glycogen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, lipid droplets, vesicles and lipid-filled vesicles. Red arrows indicate sites of cell rupture.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TEM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icture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show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  <p:sp>
        <p:nvSpPr>
          <p:cNvPr id="76" name="Textfeld 75">
            <a:extLst>
              <a:ext uri="{FF2B5EF4-FFF2-40B4-BE49-F238E27FC236}">
                <a16:creationId xmlns="" xmlns:a16="http://schemas.microsoft.com/office/drawing/2014/main" id="{061F8EB8-0E93-CF49-BF7E-A0A128DFB561}"/>
              </a:ext>
            </a:extLst>
          </p:cNvPr>
          <p:cNvSpPr txBox="1"/>
          <p:nvPr/>
        </p:nvSpPr>
        <p:spPr>
          <a:xfrm>
            <a:off x="4822457" y="6931696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feld 77">
            <a:extLst>
              <a:ext uri="{FF2B5EF4-FFF2-40B4-BE49-F238E27FC236}">
                <a16:creationId xmlns="" xmlns:a16="http://schemas.microsoft.com/office/drawing/2014/main" id="{3B981BF5-8122-204E-B70D-4FC49DDDBAFD}"/>
              </a:ext>
            </a:extLst>
          </p:cNvPr>
          <p:cNvSpPr txBox="1"/>
          <p:nvPr/>
        </p:nvSpPr>
        <p:spPr>
          <a:xfrm>
            <a:off x="5220972" y="6638062"/>
            <a:ext cx="34015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ipid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Freihandform 4">
            <a:extLst>
              <a:ext uri="{FF2B5EF4-FFF2-40B4-BE49-F238E27FC236}">
                <a16:creationId xmlns="" xmlns:a16="http://schemas.microsoft.com/office/drawing/2014/main" id="{668696A7-D764-7745-8170-4D38EC432A23}"/>
              </a:ext>
            </a:extLst>
          </p:cNvPr>
          <p:cNvSpPr/>
          <p:nvPr/>
        </p:nvSpPr>
        <p:spPr>
          <a:xfrm>
            <a:off x="4363434" y="7678854"/>
            <a:ext cx="252000" cy="216000"/>
          </a:xfrm>
          <a:custGeom>
            <a:avLst/>
            <a:gdLst>
              <a:gd name="connsiteX0" fmla="*/ 114300 w 201706"/>
              <a:gd name="connsiteY0" fmla="*/ 0 h 194982"/>
              <a:gd name="connsiteX1" fmla="*/ 40341 w 201706"/>
              <a:gd name="connsiteY1" fmla="*/ 20170 h 194982"/>
              <a:gd name="connsiteX2" fmla="*/ 40341 w 201706"/>
              <a:gd name="connsiteY2" fmla="*/ 20170 h 194982"/>
              <a:gd name="connsiteX3" fmla="*/ 0 w 201706"/>
              <a:gd name="connsiteY3" fmla="*/ 87405 h 194982"/>
              <a:gd name="connsiteX4" fmla="*/ 0 w 201706"/>
              <a:gd name="connsiteY4" fmla="*/ 87405 h 194982"/>
              <a:gd name="connsiteX5" fmla="*/ 26894 w 201706"/>
              <a:gd name="connsiteY5" fmla="*/ 181535 h 194982"/>
              <a:gd name="connsiteX6" fmla="*/ 26894 w 201706"/>
              <a:gd name="connsiteY6" fmla="*/ 181535 h 194982"/>
              <a:gd name="connsiteX7" fmla="*/ 121023 w 201706"/>
              <a:gd name="connsiteY7" fmla="*/ 194982 h 194982"/>
              <a:gd name="connsiteX8" fmla="*/ 121023 w 201706"/>
              <a:gd name="connsiteY8" fmla="*/ 194982 h 194982"/>
              <a:gd name="connsiteX9" fmla="*/ 201706 w 201706"/>
              <a:gd name="connsiteY9" fmla="*/ 121023 h 194982"/>
              <a:gd name="connsiteX10" fmla="*/ 201706 w 201706"/>
              <a:gd name="connsiteY10" fmla="*/ 121023 h 194982"/>
              <a:gd name="connsiteX11" fmla="*/ 168088 w 201706"/>
              <a:gd name="connsiteY11" fmla="*/ 40341 h 194982"/>
              <a:gd name="connsiteX12" fmla="*/ 114300 w 201706"/>
              <a:gd name="connsiteY12" fmla="*/ 0 h 1949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201706" h="194982">
                <a:moveTo>
                  <a:pt x="114300" y="0"/>
                </a:moveTo>
                <a:lnTo>
                  <a:pt x="40341" y="20170"/>
                </a:lnTo>
                <a:lnTo>
                  <a:pt x="40341" y="20170"/>
                </a:lnTo>
                <a:lnTo>
                  <a:pt x="0" y="87405"/>
                </a:lnTo>
                <a:lnTo>
                  <a:pt x="0" y="87405"/>
                </a:lnTo>
                <a:lnTo>
                  <a:pt x="26894" y="181535"/>
                </a:lnTo>
                <a:lnTo>
                  <a:pt x="26894" y="181535"/>
                </a:lnTo>
                <a:lnTo>
                  <a:pt x="121023" y="194982"/>
                </a:lnTo>
                <a:lnTo>
                  <a:pt x="121023" y="194982"/>
                </a:lnTo>
                <a:lnTo>
                  <a:pt x="201706" y="121023"/>
                </a:lnTo>
                <a:lnTo>
                  <a:pt x="201706" y="121023"/>
                </a:lnTo>
                <a:lnTo>
                  <a:pt x="168088" y="40341"/>
                </a:lnTo>
                <a:lnTo>
                  <a:pt x="114300" y="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9" name="Freihandform 78">
            <a:extLst>
              <a:ext uri="{FF2B5EF4-FFF2-40B4-BE49-F238E27FC236}">
                <a16:creationId xmlns="" xmlns:a16="http://schemas.microsoft.com/office/drawing/2014/main" id="{F1148D4B-D664-4040-9918-5FF3D845B283}"/>
              </a:ext>
            </a:extLst>
          </p:cNvPr>
          <p:cNvSpPr/>
          <p:nvPr/>
        </p:nvSpPr>
        <p:spPr>
          <a:xfrm>
            <a:off x="5689862" y="7234678"/>
            <a:ext cx="144000" cy="144000"/>
          </a:xfrm>
          <a:custGeom>
            <a:avLst/>
            <a:gdLst>
              <a:gd name="connsiteX0" fmla="*/ 114300 w 201706"/>
              <a:gd name="connsiteY0" fmla="*/ 0 h 194982"/>
              <a:gd name="connsiteX1" fmla="*/ 40341 w 201706"/>
              <a:gd name="connsiteY1" fmla="*/ 20170 h 194982"/>
              <a:gd name="connsiteX2" fmla="*/ 40341 w 201706"/>
              <a:gd name="connsiteY2" fmla="*/ 20170 h 194982"/>
              <a:gd name="connsiteX3" fmla="*/ 0 w 201706"/>
              <a:gd name="connsiteY3" fmla="*/ 87405 h 194982"/>
              <a:gd name="connsiteX4" fmla="*/ 0 w 201706"/>
              <a:gd name="connsiteY4" fmla="*/ 87405 h 194982"/>
              <a:gd name="connsiteX5" fmla="*/ 26894 w 201706"/>
              <a:gd name="connsiteY5" fmla="*/ 181535 h 194982"/>
              <a:gd name="connsiteX6" fmla="*/ 26894 w 201706"/>
              <a:gd name="connsiteY6" fmla="*/ 181535 h 194982"/>
              <a:gd name="connsiteX7" fmla="*/ 121023 w 201706"/>
              <a:gd name="connsiteY7" fmla="*/ 194982 h 194982"/>
              <a:gd name="connsiteX8" fmla="*/ 121023 w 201706"/>
              <a:gd name="connsiteY8" fmla="*/ 194982 h 194982"/>
              <a:gd name="connsiteX9" fmla="*/ 201706 w 201706"/>
              <a:gd name="connsiteY9" fmla="*/ 121023 h 194982"/>
              <a:gd name="connsiteX10" fmla="*/ 201706 w 201706"/>
              <a:gd name="connsiteY10" fmla="*/ 121023 h 194982"/>
              <a:gd name="connsiteX11" fmla="*/ 168088 w 201706"/>
              <a:gd name="connsiteY11" fmla="*/ 40341 h 194982"/>
              <a:gd name="connsiteX12" fmla="*/ 114300 w 201706"/>
              <a:gd name="connsiteY12" fmla="*/ 0 h 19498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201706" h="194982">
                <a:moveTo>
                  <a:pt x="114300" y="0"/>
                </a:moveTo>
                <a:lnTo>
                  <a:pt x="40341" y="20170"/>
                </a:lnTo>
                <a:lnTo>
                  <a:pt x="40341" y="20170"/>
                </a:lnTo>
                <a:lnTo>
                  <a:pt x="0" y="87405"/>
                </a:lnTo>
                <a:lnTo>
                  <a:pt x="0" y="87405"/>
                </a:lnTo>
                <a:lnTo>
                  <a:pt x="26894" y="181535"/>
                </a:lnTo>
                <a:lnTo>
                  <a:pt x="26894" y="181535"/>
                </a:lnTo>
                <a:lnTo>
                  <a:pt x="121023" y="194982"/>
                </a:lnTo>
                <a:lnTo>
                  <a:pt x="121023" y="194982"/>
                </a:lnTo>
                <a:lnTo>
                  <a:pt x="201706" y="121023"/>
                </a:lnTo>
                <a:lnTo>
                  <a:pt x="201706" y="121023"/>
                </a:lnTo>
                <a:lnTo>
                  <a:pt x="168088" y="40341"/>
                </a:lnTo>
                <a:lnTo>
                  <a:pt x="114300" y="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0" name="Textfeld 79">
            <a:extLst>
              <a:ext uri="{FF2B5EF4-FFF2-40B4-BE49-F238E27FC236}">
                <a16:creationId xmlns="" xmlns:a16="http://schemas.microsoft.com/office/drawing/2014/main" id="{1FAC1632-0823-514C-9F0A-6738EAEAED7C}"/>
              </a:ext>
            </a:extLst>
          </p:cNvPr>
          <p:cNvSpPr txBox="1"/>
          <p:nvPr/>
        </p:nvSpPr>
        <p:spPr>
          <a:xfrm>
            <a:off x="3794493" y="7165438"/>
            <a:ext cx="336452" cy="2752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te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feld 80">
            <a:extLst>
              <a:ext uri="{FF2B5EF4-FFF2-40B4-BE49-F238E27FC236}">
                <a16:creationId xmlns="" xmlns:a16="http://schemas.microsoft.com/office/drawing/2014/main" id="{1B6BB6FF-107B-8B4E-863C-8223FFE8FA4A}"/>
              </a:ext>
            </a:extLst>
          </p:cNvPr>
          <p:cNvSpPr txBox="1"/>
          <p:nvPr/>
        </p:nvSpPr>
        <p:spPr>
          <a:xfrm>
            <a:off x="4334256" y="6876129"/>
            <a:ext cx="336452" cy="27527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te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feld 81">
            <a:extLst>
              <a:ext uri="{FF2B5EF4-FFF2-40B4-BE49-F238E27FC236}">
                <a16:creationId xmlns="" xmlns:a16="http://schemas.microsoft.com/office/drawing/2014/main" id="{C405A616-DFF3-B643-BC96-167853598B12}"/>
              </a:ext>
            </a:extLst>
          </p:cNvPr>
          <p:cNvSpPr txBox="1"/>
          <p:nvPr/>
        </p:nvSpPr>
        <p:spPr>
          <a:xfrm>
            <a:off x="5036724" y="7953066"/>
            <a:ext cx="292068" cy="18466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16" name="Freihandform 15">
            <a:extLst>
              <a:ext uri="{FF2B5EF4-FFF2-40B4-BE49-F238E27FC236}">
                <a16:creationId xmlns="" xmlns:a16="http://schemas.microsoft.com/office/drawing/2014/main" id="{C07FB0F4-2D2A-284C-9045-0B537D26C427}"/>
              </a:ext>
            </a:extLst>
          </p:cNvPr>
          <p:cNvSpPr/>
          <p:nvPr/>
        </p:nvSpPr>
        <p:spPr>
          <a:xfrm>
            <a:off x="4330700" y="5175250"/>
            <a:ext cx="838200" cy="736600"/>
          </a:xfrm>
          <a:custGeom>
            <a:avLst/>
            <a:gdLst>
              <a:gd name="connsiteX0" fmla="*/ 95250 w 838200"/>
              <a:gd name="connsiteY0" fmla="*/ 209550 h 736600"/>
              <a:gd name="connsiteX1" fmla="*/ 6350 w 838200"/>
              <a:gd name="connsiteY1" fmla="*/ 355600 h 736600"/>
              <a:gd name="connsiteX2" fmla="*/ 6350 w 838200"/>
              <a:gd name="connsiteY2" fmla="*/ 355600 h 736600"/>
              <a:gd name="connsiteX3" fmla="*/ 0 w 838200"/>
              <a:gd name="connsiteY3" fmla="*/ 482600 h 736600"/>
              <a:gd name="connsiteX4" fmla="*/ 31750 w 838200"/>
              <a:gd name="connsiteY4" fmla="*/ 552450 h 736600"/>
              <a:gd name="connsiteX5" fmla="*/ 120650 w 838200"/>
              <a:gd name="connsiteY5" fmla="*/ 603250 h 736600"/>
              <a:gd name="connsiteX6" fmla="*/ 203200 w 838200"/>
              <a:gd name="connsiteY6" fmla="*/ 647700 h 736600"/>
              <a:gd name="connsiteX7" fmla="*/ 266700 w 838200"/>
              <a:gd name="connsiteY7" fmla="*/ 692150 h 736600"/>
              <a:gd name="connsiteX8" fmla="*/ 323850 w 838200"/>
              <a:gd name="connsiteY8" fmla="*/ 730250 h 736600"/>
              <a:gd name="connsiteX9" fmla="*/ 425450 w 838200"/>
              <a:gd name="connsiteY9" fmla="*/ 736600 h 736600"/>
              <a:gd name="connsiteX10" fmla="*/ 558800 w 838200"/>
              <a:gd name="connsiteY10" fmla="*/ 730250 h 736600"/>
              <a:gd name="connsiteX11" fmla="*/ 666750 w 838200"/>
              <a:gd name="connsiteY11" fmla="*/ 666750 h 736600"/>
              <a:gd name="connsiteX12" fmla="*/ 755650 w 838200"/>
              <a:gd name="connsiteY12" fmla="*/ 590550 h 736600"/>
              <a:gd name="connsiteX13" fmla="*/ 825500 w 838200"/>
              <a:gd name="connsiteY13" fmla="*/ 469900 h 736600"/>
              <a:gd name="connsiteX14" fmla="*/ 838200 w 838200"/>
              <a:gd name="connsiteY14" fmla="*/ 381000 h 736600"/>
              <a:gd name="connsiteX15" fmla="*/ 825500 w 838200"/>
              <a:gd name="connsiteY15" fmla="*/ 247650 h 736600"/>
              <a:gd name="connsiteX16" fmla="*/ 723900 w 838200"/>
              <a:gd name="connsiteY16" fmla="*/ 120650 h 736600"/>
              <a:gd name="connsiteX17" fmla="*/ 654050 w 838200"/>
              <a:gd name="connsiteY17" fmla="*/ 69850 h 736600"/>
              <a:gd name="connsiteX18" fmla="*/ 533400 w 838200"/>
              <a:gd name="connsiteY18" fmla="*/ 38100 h 736600"/>
              <a:gd name="connsiteX19" fmla="*/ 393700 w 838200"/>
              <a:gd name="connsiteY19" fmla="*/ 0 h 736600"/>
              <a:gd name="connsiteX20" fmla="*/ 342900 w 838200"/>
              <a:gd name="connsiteY20" fmla="*/ 31750 h 736600"/>
              <a:gd name="connsiteX21" fmla="*/ 285750 w 838200"/>
              <a:gd name="connsiteY21" fmla="*/ 76200 h 736600"/>
              <a:gd name="connsiteX22" fmla="*/ 241300 w 838200"/>
              <a:gd name="connsiteY22" fmla="*/ 139700 h 736600"/>
              <a:gd name="connsiteX23" fmla="*/ 190500 w 838200"/>
              <a:gd name="connsiteY23" fmla="*/ 177800 h 736600"/>
              <a:gd name="connsiteX24" fmla="*/ 95250 w 838200"/>
              <a:gd name="connsiteY24" fmla="*/ 209550 h 736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838200" h="736600">
                <a:moveTo>
                  <a:pt x="95250" y="209550"/>
                </a:moveTo>
                <a:lnTo>
                  <a:pt x="6350" y="355600"/>
                </a:lnTo>
                <a:lnTo>
                  <a:pt x="6350" y="355600"/>
                </a:lnTo>
                <a:lnTo>
                  <a:pt x="0" y="482600"/>
                </a:lnTo>
                <a:lnTo>
                  <a:pt x="31750" y="552450"/>
                </a:lnTo>
                <a:lnTo>
                  <a:pt x="120650" y="603250"/>
                </a:lnTo>
                <a:lnTo>
                  <a:pt x="203200" y="647700"/>
                </a:lnTo>
                <a:lnTo>
                  <a:pt x="266700" y="692150"/>
                </a:lnTo>
                <a:lnTo>
                  <a:pt x="323850" y="730250"/>
                </a:lnTo>
                <a:lnTo>
                  <a:pt x="425450" y="736600"/>
                </a:lnTo>
                <a:lnTo>
                  <a:pt x="558800" y="730250"/>
                </a:lnTo>
                <a:lnTo>
                  <a:pt x="666750" y="666750"/>
                </a:lnTo>
                <a:lnTo>
                  <a:pt x="755650" y="590550"/>
                </a:lnTo>
                <a:lnTo>
                  <a:pt x="825500" y="469900"/>
                </a:lnTo>
                <a:lnTo>
                  <a:pt x="838200" y="381000"/>
                </a:lnTo>
                <a:lnTo>
                  <a:pt x="825500" y="247650"/>
                </a:lnTo>
                <a:lnTo>
                  <a:pt x="723900" y="120650"/>
                </a:lnTo>
                <a:lnTo>
                  <a:pt x="654050" y="69850"/>
                </a:lnTo>
                <a:lnTo>
                  <a:pt x="533400" y="38100"/>
                </a:lnTo>
                <a:lnTo>
                  <a:pt x="393700" y="0"/>
                </a:lnTo>
                <a:lnTo>
                  <a:pt x="342900" y="31750"/>
                </a:lnTo>
                <a:lnTo>
                  <a:pt x="285750" y="76200"/>
                </a:lnTo>
                <a:lnTo>
                  <a:pt x="241300" y="139700"/>
                </a:lnTo>
                <a:lnTo>
                  <a:pt x="190500" y="177800"/>
                </a:lnTo>
                <a:lnTo>
                  <a:pt x="95250" y="20955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3" name="Freihandform 82">
            <a:extLst>
              <a:ext uri="{FF2B5EF4-FFF2-40B4-BE49-F238E27FC236}">
                <a16:creationId xmlns="" xmlns:a16="http://schemas.microsoft.com/office/drawing/2014/main" id="{6D6BCD82-4E36-274E-B422-7C28DAD80054}"/>
              </a:ext>
            </a:extLst>
          </p:cNvPr>
          <p:cNvSpPr/>
          <p:nvPr/>
        </p:nvSpPr>
        <p:spPr>
          <a:xfrm>
            <a:off x="1544097" y="7727538"/>
            <a:ext cx="261907" cy="251329"/>
          </a:xfrm>
          <a:custGeom>
            <a:avLst/>
            <a:gdLst>
              <a:gd name="connsiteX0" fmla="*/ 95250 w 838200"/>
              <a:gd name="connsiteY0" fmla="*/ 209550 h 736600"/>
              <a:gd name="connsiteX1" fmla="*/ 6350 w 838200"/>
              <a:gd name="connsiteY1" fmla="*/ 355600 h 736600"/>
              <a:gd name="connsiteX2" fmla="*/ 6350 w 838200"/>
              <a:gd name="connsiteY2" fmla="*/ 355600 h 736600"/>
              <a:gd name="connsiteX3" fmla="*/ 0 w 838200"/>
              <a:gd name="connsiteY3" fmla="*/ 482600 h 736600"/>
              <a:gd name="connsiteX4" fmla="*/ 31750 w 838200"/>
              <a:gd name="connsiteY4" fmla="*/ 552450 h 736600"/>
              <a:gd name="connsiteX5" fmla="*/ 120650 w 838200"/>
              <a:gd name="connsiteY5" fmla="*/ 603250 h 736600"/>
              <a:gd name="connsiteX6" fmla="*/ 203200 w 838200"/>
              <a:gd name="connsiteY6" fmla="*/ 647700 h 736600"/>
              <a:gd name="connsiteX7" fmla="*/ 266700 w 838200"/>
              <a:gd name="connsiteY7" fmla="*/ 692150 h 736600"/>
              <a:gd name="connsiteX8" fmla="*/ 323850 w 838200"/>
              <a:gd name="connsiteY8" fmla="*/ 730250 h 736600"/>
              <a:gd name="connsiteX9" fmla="*/ 425450 w 838200"/>
              <a:gd name="connsiteY9" fmla="*/ 736600 h 736600"/>
              <a:gd name="connsiteX10" fmla="*/ 558800 w 838200"/>
              <a:gd name="connsiteY10" fmla="*/ 730250 h 736600"/>
              <a:gd name="connsiteX11" fmla="*/ 666750 w 838200"/>
              <a:gd name="connsiteY11" fmla="*/ 666750 h 736600"/>
              <a:gd name="connsiteX12" fmla="*/ 755650 w 838200"/>
              <a:gd name="connsiteY12" fmla="*/ 590550 h 736600"/>
              <a:gd name="connsiteX13" fmla="*/ 825500 w 838200"/>
              <a:gd name="connsiteY13" fmla="*/ 469900 h 736600"/>
              <a:gd name="connsiteX14" fmla="*/ 838200 w 838200"/>
              <a:gd name="connsiteY14" fmla="*/ 381000 h 736600"/>
              <a:gd name="connsiteX15" fmla="*/ 825500 w 838200"/>
              <a:gd name="connsiteY15" fmla="*/ 247650 h 736600"/>
              <a:gd name="connsiteX16" fmla="*/ 723900 w 838200"/>
              <a:gd name="connsiteY16" fmla="*/ 120650 h 736600"/>
              <a:gd name="connsiteX17" fmla="*/ 654050 w 838200"/>
              <a:gd name="connsiteY17" fmla="*/ 69850 h 736600"/>
              <a:gd name="connsiteX18" fmla="*/ 533400 w 838200"/>
              <a:gd name="connsiteY18" fmla="*/ 38100 h 736600"/>
              <a:gd name="connsiteX19" fmla="*/ 393700 w 838200"/>
              <a:gd name="connsiteY19" fmla="*/ 0 h 736600"/>
              <a:gd name="connsiteX20" fmla="*/ 342900 w 838200"/>
              <a:gd name="connsiteY20" fmla="*/ 31750 h 736600"/>
              <a:gd name="connsiteX21" fmla="*/ 285750 w 838200"/>
              <a:gd name="connsiteY21" fmla="*/ 76200 h 736600"/>
              <a:gd name="connsiteX22" fmla="*/ 241300 w 838200"/>
              <a:gd name="connsiteY22" fmla="*/ 139700 h 736600"/>
              <a:gd name="connsiteX23" fmla="*/ 190500 w 838200"/>
              <a:gd name="connsiteY23" fmla="*/ 177800 h 736600"/>
              <a:gd name="connsiteX24" fmla="*/ 95250 w 838200"/>
              <a:gd name="connsiteY24" fmla="*/ 209550 h 736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838200" h="736600">
                <a:moveTo>
                  <a:pt x="95250" y="209550"/>
                </a:moveTo>
                <a:lnTo>
                  <a:pt x="6350" y="355600"/>
                </a:lnTo>
                <a:lnTo>
                  <a:pt x="6350" y="355600"/>
                </a:lnTo>
                <a:lnTo>
                  <a:pt x="0" y="482600"/>
                </a:lnTo>
                <a:lnTo>
                  <a:pt x="31750" y="552450"/>
                </a:lnTo>
                <a:lnTo>
                  <a:pt x="120650" y="603250"/>
                </a:lnTo>
                <a:lnTo>
                  <a:pt x="203200" y="647700"/>
                </a:lnTo>
                <a:lnTo>
                  <a:pt x="266700" y="692150"/>
                </a:lnTo>
                <a:lnTo>
                  <a:pt x="323850" y="730250"/>
                </a:lnTo>
                <a:lnTo>
                  <a:pt x="425450" y="736600"/>
                </a:lnTo>
                <a:lnTo>
                  <a:pt x="558800" y="730250"/>
                </a:lnTo>
                <a:lnTo>
                  <a:pt x="666750" y="666750"/>
                </a:lnTo>
                <a:lnTo>
                  <a:pt x="755650" y="590550"/>
                </a:lnTo>
                <a:lnTo>
                  <a:pt x="825500" y="469900"/>
                </a:lnTo>
                <a:lnTo>
                  <a:pt x="838200" y="381000"/>
                </a:lnTo>
                <a:lnTo>
                  <a:pt x="825500" y="247650"/>
                </a:lnTo>
                <a:lnTo>
                  <a:pt x="723900" y="120650"/>
                </a:lnTo>
                <a:lnTo>
                  <a:pt x="654050" y="69850"/>
                </a:lnTo>
                <a:lnTo>
                  <a:pt x="533400" y="38100"/>
                </a:lnTo>
                <a:lnTo>
                  <a:pt x="393700" y="0"/>
                </a:lnTo>
                <a:lnTo>
                  <a:pt x="342900" y="31750"/>
                </a:lnTo>
                <a:lnTo>
                  <a:pt x="285750" y="76200"/>
                </a:lnTo>
                <a:lnTo>
                  <a:pt x="241300" y="139700"/>
                </a:lnTo>
                <a:lnTo>
                  <a:pt x="190500" y="177800"/>
                </a:lnTo>
                <a:lnTo>
                  <a:pt x="95250" y="20955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4" name="Textfeld 83">
            <a:extLst>
              <a:ext uri="{FF2B5EF4-FFF2-40B4-BE49-F238E27FC236}">
                <a16:creationId xmlns="" xmlns:a16="http://schemas.microsoft.com/office/drawing/2014/main" id="{3DF08712-3F02-564E-8644-F63AAE0E48DD}"/>
              </a:ext>
            </a:extLst>
          </p:cNvPr>
          <p:cNvSpPr txBox="1"/>
          <p:nvPr/>
        </p:nvSpPr>
        <p:spPr>
          <a:xfrm>
            <a:off x="1408435" y="7927541"/>
            <a:ext cx="52129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b="1" dirty="0" err="1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ycogen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Gerade Verbindung mit Pfeil 19">
            <a:extLst>
              <a:ext uri="{FF2B5EF4-FFF2-40B4-BE49-F238E27FC236}">
                <a16:creationId xmlns="" xmlns:a16="http://schemas.microsoft.com/office/drawing/2014/main" id="{5232B82C-8B63-F842-A5A2-A835E98F3481}"/>
              </a:ext>
            </a:extLst>
          </p:cNvPr>
          <p:cNvCxnSpPr>
            <a:cxnSpLocks/>
          </p:cNvCxnSpPr>
          <p:nvPr/>
        </p:nvCxnSpPr>
        <p:spPr>
          <a:xfrm flipH="1" flipV="1">
            <a:off x="1154990" y="5839579"/>
            <a:ext cx="201764" cy="10492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 Verbindung mit Pfeil 84">
            <a:extLst>
              <a:ext uri="{FF2B5EF4-FFF2-40B4-BE49-F238E27FC236}">
                <a16:creationId xmlns="" xmlns:a16="http://schemas.microsoft.com/office/drawing/2014/main" id="{AC9D3A27-C13C-A74E-BC0F-60ACF384167A}"/>
              </a:ext>
            </a:extLst>
          </p:cNvPr>
          <p:cNvCxnSpPr>
            <a:cxnSpLocks/>
          </p:cNvCxnSpPr>
          <p:nvPr/>
        </p:nvCxnSpPr>
        <p:spPr>
          <a:xfrm flipH="1" flipV="1">
            <a:off x="2922436" y="3519465"/>
            <a:ext cx="201764" cy="104921"/>
          </a:xfrm>
          <a:prstGeom prst="straightConnector1">
            <a:avLst/>
          </a:prstGeom>
          <a:ln w="127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feld 85">
            <a:extLst>
              <a:ext uri="{FF2B5EF4-FFF2-40B4-BE49-F238E27FC236}">
                <a16:creationId xmlns="" xmlns:a16="http://schemas.microsoft.com/office/drawing/2014/main" id="{20A298AF-75D6-0546-841E-6BAFA502646D}"/>
              </a:ext>
            </a:extLst>
          </p:cNvPr>
          <p:cNvSpPr txBox="1"/>
          <p:nvPr/>
        </p:nvSpPr>
        <p:spPr>
          <a:xfrm>
            <a:off x="2200593" y="5812995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88" name="Textfeld 87">
            <a:extLst>
              <a:ext uri="{FF2B5EF4-FFF2-40B4-BE49-F238E27FC236}">
                <a16:creationId xmlns="" xmlns:a16="http://schemas.microsoft.com/office/drawing/2014/main" id="{EB438289-993A-5A4A-AE4A-C8DAF8824A86}"/>
              </a:ext>
            </a:extLst>
          </p:cNvPr>
          <p:cNvSpPr txBox="1"/>
          <p:nvPr/>
        </p:nvSpPr>
        <p:spPr>
          <a:xfrm>
            <a:off x="1693117" y="3713873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feld 88">
            <a:extLst>
              <a:ext uri="{FF2B5EF4-FFF2-40B4-BE49-F238E27FC236}">
                <a16:creationId xmlns="" xmlns:a16="http://schemas.microsoft.com/office/drawing/2014/main" id="{4FAA3033-431F-F74C-B95E-725595B5F2B6}"/>
              </a:ext>
            </a:extLst>
          </p:cNvPr>
          <p:cNvSpPr txBox="1"/>
          <p:nvPr/>
        </p:nvSpPr>
        <p:spPr>
          <a:xfrm>
            <a:off x="963804" y="3887438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90" name="Freihandform 89">
            <a:extLst>
              <a:ext uri="{FF2B5EF4-FFF2-40B4-BE49-F238E27FC236}">
                <a16:creationId xmlns="" xmlns:a16="http://schemas.microsoft.com/office/drawing/2014/main" id="{D1162E38-821E-C04E-A6F8-4F4FDE1EFBBD}"/>
              </a:ext>
            </a:extLst>
          </p:cNvPr>
          <p:cNvSpPr/>
          <p:nvPr/>
        </p:nvSpPr>
        <p:spPr>
          <a:xfrm>
            <a:off x="416555" y="3217566"/>
            <a:ext cx="192911" cy="202138"/>
          </a:xfrm>
          <a:custGeom>
            <a:avLst/>
            <a:gdLst>
              <a:gd name="connsiteX0" fmla="*/ 95250 w 838200"/>
              <a:gd name="connsiteY0" fmla="*/ 209550 h 736600"/>
              <a:gd name="connsiteX1" fmla="*/ 6350 w 838200"/>
              <a:gd name="connsiteY1" fmla="*/ 355600 h 736600"/>
              <a:gd name="connsiteX2" fmla="*/ 6350 w 838200"/>
              <a:gd name="connsiteY2" fmla="*/ 355600 h 736600"/>
              <a:gd name="connsiteX3" fmla="*/ 0 w 838200"/>
              <a:gd name="connsiteY3" fmla="*/ 482600 h 736600"/>
              <a:gd name="connsiteX4" fmla="*/ 31750 w 838200"/>
              <a:gd name="connsiteY4" fmla="*/ 552450 h 736600"/>
              <a:gd name="connsiteX5" fmla="*/ 120650 w 838200"/>
              <a:gd name="connsiteY5" fmla="*/ 603250 h 736600"/>
              <a:gd name="connsiteX6" fmla="*/ 203200 w 838200"/>
              <a:gd name="connsiteY6" fmla="*/ 647700 h 736600"/>
              <a:gd name="connsiteX7" fmla="*/ 266700 w 838200"/>
              <a:gd name="connsiteY7" fmla="*/ 692150 h 736600"/>
              <a:gd name="connsiteX8" fmla="*/ 323850 w 838200"/>
              <a:gd name="connsiteY8" fmla="*/ 730250 h 736600"/>
              <a:gd name="connsiteX9" fmla="*/ 425450 w 838200"/>
              <a:gd name="connsiteY9" fmla="*/ 736600 h 736600"/>
              <a:gd name="connsiteX10" fmla="*/ 558800 w 838200"/>
              <a:gd name="connsiteY10" fmla="*/ 730250 h 736600"/>
              <a:gd name="connsiteX11" fmla="*/ 666750 w 838200"/>
              <a:gd name="connsiteY11" fmla="*/ 666750 h 736600"/>
              <a:gd name="connsiteX12" fmla="*/ 755650 w 838200"/>
              <a:gd name="connsiteY12" fmla="*/ 590550 h 736600"/>
              <a:gd name="connsiteX13" fmla="*/ 825500 w 838200"/>
              <a:gd name="connsiteY13" fmla="*/ 469900 h 736600"/>
              <a:gd name="connsiteX14" fmla="*/ 838200 w 838200"/>
              <a:gd name="connsiteY14" fmla="*/ 381000 h 736600"/>
              <a:gd name="connsiteX15" fmla="*/ 825500 w 838200"/>
              <a:gd name="connsiteY15" fmla="*/ 247650 h 736600"/>
              <a:gd name="connsiteX16" fmla="*/ 723900 w 838200"/>
              <a:gd name="connsiteY16" fmla="*/ 120650 h 736600"/>
              <a:gd name="connsiteX17" fmla="*/ 654050 w 838200"/>
              <a:gd name="connsiteY17" fmla="*/ 69850 h 736600"/>
              <a:gd name="connsiteX18" fmla="*/ 533400 w 838200"/>
              <a:gd name="connsiteY18" fmla="*/ 38100 h 736600"/>
              <a:gd name="connsiteX19" fmla="*/ 393700 w 838200"/>
              <a:gd name="connsiteY19" fmla="*/ 0 h 736600"/>
              <a:gd name="connsiteX20" fmla="*/ 342900 w 838200"/>
              <a:gd name="connsiteY20" fmla="*/ 31750 h 736600"/>
              <a:gd name="connsiteX21" fmla="*/ 285750 w 838200"/>
              <a:gd name="connsiteY21" fmla="*/ 76200 h 736600"/>
              <a:gd name="connsiteX22" fmla="*/ 241300 w 838200"/>
              <a:gd name="connsiteY22" fmla="*/ 139700 h 736600"/>
              <a:gd name="connsiteX23" fmla="*/ 190500 w 838200"/>
              <a:gd name="connsiteY23" fmla="*/ 177800 h 736600"/>
              <a:gd name="connsiteX24" fmla="*/ 95250 w 838200"/>
              <a:gd name="connsiteY24" fmla="*/ 209550 h 736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</a:cxnLst>
            <a:rect l="l" t="t" r="r" b="b"/>
            <a:pathLst>
              <a:path w="838200" h="736600">
                <a:moveTo>
                  <a:pt x="95250" y="209550"/>
                </a:moveTo>
                <a:lnTo>
                  <a:pt x="6350" y="355600"/>
                </a:lnTo>
                <a:lnTo>
                  <a:pt x="6350" y="355600"/>
                </a:lnTo>
                <a:lnTo>
                  <a:pt x="0" y="482600"/>
                </a:lnTo>
                <a:lnTo>
                  <a:pt x="31750" y="552450"/>
                </a:lnTo>
                <a:lnTo>
                  <a:pt x="120650" y="603250"/>
                </a:lnTo>
                <a:lnTo>
                  <a:pt x="203200" y="647700"/>
                </a:lnTo>
                <a:lnTo>
                  <a:pt x="266700" y="692150"/>
                </a:lnTo>
                <a:lnTo>
                  <a:pt x="323850" y="730250"/>
                </a:lnTo>
                <a:lnTo>
                  <a:pt x="425450" y="736600"/>
                </a:lnTo>
                <a:lnTo>
                  <a:pt x="558800" y="730250"/>
                </a:lnTo>
                <a:lnTo>
                  <a:pt x="666750" y="666750"/>
                </a:lnTo>
                <a:lnTo>
                  <a:pt x="755650" y="590550"/>
                </a:lnTo>
                <a:lnTo>
                  <a:pt x="825500" y="469900"/>
                </a:lnTo>
                <a:lnTo>
                  <a:pt x="838200" y="381000"/>
                </a:lnTo>
                <a:lnTo>
                  <a:pt x="825500" y="247650"/>
                </a:lnTo>
                <a:lnTo>
                  <a:pt x="723900" y="120650"/>
                </a:lnTo>
                <a:lnTo>
                  <a:pt x="654050" y="69850"/>
                </a:lnTo>
                <a:lnTo>
                  <a:pt x="533400" y="38100"/>
                </a:lnTo>
                <a:lnTo>
                  <a:pt x="393700" y="0"/>
                </a:lnTo>
                <a:lnTo>
                  <a:pt x="342900" y="31750"/>
                </a:lnTo>
                <a:lnTo>
                  <a:pt x="285750" y="76200"/>
                </a:lnTo>
                <a:lnTo>
                  <a:pt x="241300" y="139700"/>
                </a:lnTo>
                <a:lnTo>
                  <a:pt x="190500" y="177800"/>
                </a:lnTo>
                <a:lnTo>
                  <a:pt x="95250" y="209550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1" name="Textfeld 90">
            <a:extLst>
              <a:ext uri="{FF2B5EF4-FFF2-40B4-BE49-F238E27FC236}">
                <a16:creationId xmlns="" xmlns:a16="http://schemas.microsoft.com/office/drawing/2014/main" id="{FA6F8FD3-0E96-6947-9F40-6F5626946EC7}"/>
              </a:ext>
            </a:extLst>
          </p:cNvPr>
          <p:cNvSpPr txBox="1"/>
          <p:nvPr/>
        </p:nvSpPr>
        <p:spPr>
          <a:xfrm>
            <a:off x="348817" y="3419704"/>
            <a:ext cx="52129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ycagon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feld 91">
            <a:extLst>
              <a:ext uri="{FF2B5EF4-FFF2-40B4-BE49-F238E27FC236}">
                <a16:creationId xmlns="" xmlns:a16="http://schemas.microsoft.com/office/drawing/2014/main" id="{47397BF9-A4F2-A746-91DC-C41E3F3A76D5}"/>
              </a:ext>
            </a:extLst>
          </p:cNvPr>
          <p:cNvSpPr txBox="1"/>
          <p:nvPr/>
        </p:nvSpPr>
        <p:spPr>
          <a:xfrm>
            <a:off x="2321943" y="3845340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feld 92">
            <a:extLst>
              <a:ext uri="{FF2B5EF4-FFF2-40B4-BE49-F238E27FC236}">
                <a16:creationId xmlns="" xmlns:a16="http://schemas.microsoft.com/office/drawing/2014/main" id="{9CCC9851-4F45-9249-9CD7-55831F9411BF}"/>
              </a:ext>
            </a:extLst>
          </p:cNvPr>
          <p:cNvSpPr txBox="1"/>
          <p:nvPr/>
        </p:nvSpPr>
        <p:spPr>
          <a:xfrm>
            <a:off x="4268864" y="3621540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feld 93">
            <a:extLst>
              <a:ext uri="{FF2B5EF4-FFF2-40B4-BE49-F238E27FC236}">
                <a16:creationId xmlns="" xmlns:a16="http://schemas.microsoft.com/office/drawing/2014/main" id="{9725AEEB-76F9-0442-A6B7-95901198972B}"/>
              </a:ext>
            </a:extLst>
          </p:cNvPr>
          <p:cNvSpPr txBox="1"/>
          <p:nvPr/>
        </p:nvSpPr>
        <p:spPr>
          <a:xfrm>
            <a:off x="5198840" y="3999724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95" name="Textfeld 94">
            <a:extLst>
              <a:ext uri="{FF2B5EF4-FFF2-40B4-BE49-F238E27FC236}">
                <a16:creationId xmlns="" xmlns:a16="http://schemas.microsoft.com/office/drawing/2014/main" id="{FE4BCC3D-8779-4B4A-951F-EAA4BB7B14D3}"/>
              </a:ext>
            </a:extLst>
          </p:cNvPr>
          <p:cNvSpPr txBox="1"/>
          <p:nvPr/>
        </p:nvSpPr>
        <p:spPr>
          <a:xfrm>
            <a:off x="4345152" y="3024529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Freihandform 21">
            <a:extLst>
              <a:ext uri="{FF2B5EF4-FFF2-40B4-BE49-F238E27FC236}">
                <a16:creationId xmlns="" xmlns:a16="http://schemas.microsoft.com/office/drawing/2014/main" id="{7E189EE9-5A55-984B-B6EA-9C672031197F}"/>
              </a:ext>
            </a:extLst>
          </p:cNvPr>
          <p:cNvSpPr/>
          <p:nvPr/>
        </p:nvSpPr>
        <p:spPr>
          <a:xfrm>
            <a:off x="5458047" y="3444949"/>
            <a:ext cx="276446" cy="326065"/>
          </a:xfrm>
          <a:custGeom>
            <a:avLst/>
            <a:gdLst>
              <a:gd name="connsiteX0" fmla="*/ 63795 w 276446"/>
              <a:gd name="connsiteY0" fmla="*/ 28353 h 326065"/>
              <a:gd name="connsiteX1" fmla="*/ 63795 w 276446"/>
              <a:gd name="connsiteY1" fmla="*/ 28353 h 326065"/>
              <a:gd name="connsiteX2" fmla="*/ 14176 w 276446"/>
              <a:gd name="connsiteY2" fmla="*/ 120502 h 326065"/>
              <a:gd name="connsiteX3" fmla="*/ 7088 w 276446"/>
              <a:gd name="connsiteY3" fmla="*/ 163032 h 326065"/>
              <a:gd name="connsiteX4" fmla="*/ 0 w 276446"/>
              <a:gd name="connsiteY4" fmla="*/ 219739 h 326065"/>
              <a:gd name="connsiteX5" fmla="*/ 28353 w 276446"/>
              <a:gd name="connsiteY5" fmla="*/ 276446 h 326065"/>
              <a:gd name="connsiteX6" fmla="*/ 28353 w 276446"/>
              <a:gd name="connsiteY6" fmla="*/ 276446 h 326065"/>
              <a:gd name="connsiteX7" fmla="*/ 120502 w 276446"/>
              <a:gd name="connsiteY7" fmla="*/ 318977 h 326065"/>
              <a:gd name="connsiteX8" fmla="*/ 177209 w 276446"/>
              <a:gd name="connsiteY8" fmla="*/ 326065 h 326065"/>
              <a:gd name="connsiteX9" fmla="*/ 241004 w 276446"/>
              <a:gd name="connsiteY9" fmla="*/ 311888 h 326065"/>
              <a:gd name="connsiteX10" fmla="*/ 241004 w 276446"/>
              <a:gd name="connsiteY10" fmla="*/ 311888 h 326065"/>
              <a:gd name="connsiteX11" fmla="*/ 248093 w 276446"/>
              <a:gd name="connsiteY11" fmla="*/ 226828 h 326065"/>
              <a:gd name="connsiteX12" fmla="*/ 233916 w 276446"/>
              <a:gd name="connsiteY12" fmla="*/ 198474 h 326065"/>
              <a:gd name="connsiteX13" fmla="*/ 255181 w 276446"/>
              <a:gd name="connsiteY13" fmla="*/ 155944 h 326065"/>
              <a:gd name="connsiteX14" fmla="*/ 276446 w 276446"/>
              <a:gd name="connsiteY14" fmla="*/ 134679 h 326065"/>
              <a:gd name="connsiteX15" fmla="*/ 248093 w 276446"/>
              <a:gd name="connsiteY15" fmla="*/ 70884 h 326065"/>
              <a:gd name="connsiteX16" fmla="*/ 212651 w 276446"/>
              <a:gd name="connsiteY16" fmla="*/ 7088 h 326065"/>
              <a:gd name="connsiteX17" fmla="*/ 191386 w 276446"/>
              <a:gd name="connsiteY17" fmla="*/ 0 h 326065"/>
              <a:gd name="connsiteX18" fmla="*/ 191386 w 276446"/>
              <a:gd name="connsiteY18" fmla="*/ 0 h 326065"/>
              <a:gd name="connsiteX19" fmla="*/ 113413 w 276446"/>
              <a:gd name="connsiteY19" fmla="*/ 35442 h 326065"/>
              <a:gd name="connsiteX20" fmla="*/ 63795 w 276446"/>
              <a:gd name="connsiteY20" fmla="*/ 28353 h 32606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</a:cxnLst>
            <a:rect l="l" t="t" r="r" b="b"/>
            <a:pathLst>
              <a:path w="276446" h="326065">
                <a:moveTo>
                  <a:pt x="63795" y="28353"/>
                </a:moveTo>
                <a:lnTo>
                  <a:pt x="63795" y="28353"/>
                </a:lnTo>
                <a:lnTo>
                  <a:pt x="14176" y="120502"/>
                </a:lnTo>
                <a:lnTo>
                  <a:pt x="7088" y="163032"/>
                </a:lnTo>
                <a:lnTo>
                  <a:pt x="0" y="219739"/>
                </a:lnTo>
                <a:lnTo>
                  <a:pt x="28353" y="276446"/>
                </a:lnTo>
                <a:lnTo>
                  <a:pt x="28353" y="276446"/>
                </a:lnTo>
                <a:lnTo>
                  <a:pt x="120502" y="318977"/>
                </a:lnTo>
                <a:lnTo>
                  <a:pt x="177209" y="326065"/>
                </a:lnTo>
                <a:lnTo>
                  <a:pt x="241004" y="311888"/>
                </a:lnTo>
                <a:lnTo>
                  <a:pt x="241004" y="311888"/>
                </a:lnTo>
                <a:lnTo>
                  <a:pt x="248093" y="226828"/>
                </a:lnTo>
                <a:lnTo>
                  <a:pt x="233916" y="198474"/>
                </a:lnTo>
                <a:lnTo>
                  <a:pt x="255181" y="155944"/>
                </a:lnTo>
                <a:lnTo>
                  <a:pt x="276446" y="134679"/>
                </a:lnTo>
                <a:lnTo>
                  <a:pt x="248093" y="70884"/>
                </a:lnTo>
                <a:lnTo>
                  <a:pt x="212651" y="7088"/>
                </a:lnTo>
                <a:lnTo>
                  <a:pt x="191386" y="0"/>
                </a:lnTo>
                <a:lnTo>
                  <a:pt x="191386" y="0"/>
                </a:lnTo>
                <a:lnTo>
                  <a:pt x="113413" y="35442"/>
                </a:lnTo>
                <a:lnTo>
                  <a:pt x="63795" y="28353"/>
                </a:lnTo>
                <a:close/>
              </a:path>
            </a:pathLst>
          </a:custGeom>
          <a:noFill/>
          <a:ln w="952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6" name="Textfeld 95">
            <a:extLst>
              <a:ext uri="{FF2B5EF4-FFF2-40B4-BE49-F238E27FC236}">
                <a16:creationId xmlns="" xmlns:a16="http://schemas.microsoft.com/office/drawing/2014/main" id="{7D5E0E4D-4D85-404E-9446-37155CD19411}"/>
              </a:ext>
            </a:extLst>
          </p:cNvPr>
          <p:cNvSpPr txBox="1"/>
          <p:nvPr/>
        </p:nvSpPr>
        <p:spPr>
          <a:xfrm>
            <a:off x="2022029" y="5239545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feld 96">
            <a:extLst>
              <a:ext uri="{FF2B5EF4-FFF2-40B4-BE49-F238E27FC236}">
                <a16:creationId xmlns="" xmlns:a16="http://schemas.microsoft.com/office/drawing/2014/main" id="{3148E70E-4B37-7F4B-AA80-F0ED5098ED62}"/>
              </a:ext>
            </a:extLst>
          </p:cNvPr>
          <p:cNvSpPr txBox="1"/>
          <p:nvPr/>
        </p:nvSpPr>
        <p:spPr>
          <a:xfrm>
            <a:off x="4407971" y="3190760"/>
            <a:ext cx="3385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ys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feld 97">
            <a:extLst>
              <a:ext uri="{FF2B5EF4-FFF2-40B4-BE49-F238E27FC236}">
                <a16:creationId xmlns="" xmlns:a16="http://schemas.microsoft.com/office/drawing/2014/main" id="{66F4D1DF-870E-A341-8D5F-33A984FA063E}"/>
              </a:ext>
            </a:extLst>
          </p:cNvPr>
          <p:cNvSpPr txBox="1"/>
          <p:nvPr/>
        </p:nvSpPr>
        <p:spPr>
          <a:xfrm>
            <a:off x="5014047" y="1465347"/>
            <a:ext cx="3465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</a:t>
            </a:r>
            <a:endParaRPr lang="de-DE" sz="6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feld 98">
            <a:extLst>
              <a:ext uri="{FF2B5EF4-FFF2-40B4-BE49-F238E27FC236}">
                <a16:creationId xmlns="" xmlns:a16="http://schemas.microsoft.com/office/drawing/2014/main" id="{6D11E192-708F-C04D-9D62-7044243F2E35}"/>
              </a:ext>
            </a:extLst>
          </p:cNvPr>
          <p:cNvSpPr txBox="1"/>
          <p:nvPr/>
        </p:nvSpPr>
        <p:spPr>
          <a:xfrm>
            <a:off x="5615828" y="1773187"/>
            <a:ext cx="29206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6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R</a:t>
            </a:r>
          </a:p>
        </p:txBody>
      </p:sp>
      <p:sp>
        <p:nvSpPr>
          <p:cNvPr id="100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6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5711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7</Words>
  <Application>Microsoft Office PowerPoint</Application>
  <PresentationFormat>A4-Papier (210x297 mm)</PresentationFormat>
  <Paragraphs>6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7:47Z</dcterms:modified>
</cp:coreProperties>
</file>